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9B834-ED03-4A78-8DDB-E73C7B9682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1E0DA-D680-467D-911F-4203886632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0A8AC-95B1-45FB-87DC-E71A83C207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974DD-A22F-486E-8DD7-CF8F5DC69A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CF2807-09E6-46E7-B95E-7FEAD3D64E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31195-BA35-4EE5-A4D7-C7A3501AF7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76B13-9FA5-4231-8602-4CEFB32F06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43A6A-84F7-4C72-963C-C9826268CD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6BA66-7FE2-4677-BF3F-59FABD4018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A905F-4A38-41FA-9F2C-1662B17DA5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9B81F-BFF9-4544-B914-A46089C4CF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AB416-DA87-4A82-BC95-B22C5C5E40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03E83B-517F-4108-9D9D-DE4F520B900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81000" y="1403280"/>
            <a:ext cx="4686480" cy="35146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981000" y="4932360"/>
            <a:ext cx="4686480" cy="351468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514440" y="488880"/>
            <a:ext cx="596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upplementary Figure S1. Numbers of female mosquitoes trapped in the MM-X trap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n Experiment 1. (A)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 Culex spp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B)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Mansoni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p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66800" y="161928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766800" y="514836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5T15:11:21Z</dcterms:created>
  <dc:creator>dconway</dc:creator>
  <dc:description/>
  <dc:language>en-US</dc:language>
  <cp:lastModifiedBy>dconway</cp:lastModifiedBy>
  <dcterms:modified xsi:type="dcterms:W3CDTF">2009-09-25T15:14:01Z</dcterms:modified>
  <cp:revision>1</cp:revision>
  <dc:subject/>
  <dc:title>Slide 1</dc:title>
</cp:coreProperties>
</file>